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104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481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073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716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439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972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94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223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3501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83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126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044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02365C-9C4F-4B24-A543-7C328F7704AB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4EF5CE-93EC-4A53-A8C4-777AFC9E9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903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424" r="83799"/>
          <a:stretch/>
        </p:blipFill>
        <p:spPr bwMode="auto">
          <a:xfrm>
            <a:off x="304800" y="1295400"/>
            <a:ext cx="3756676" cy="2971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538621" y="816486"/>
            <a:ext cx="5776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Leaf</a:t>
            </a:r>
            <a:endParaRPr lang="en-US" dirty="0"/>
          </a:p>
        </p:txBody>
      </p:sp>
      <p:pic>
        <p:nvPicPr>
          <p:cNvPr id="6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947" r="82642"/>
          <a:stretch/>
        </p:blipFill>
        <p:spPr bwMode="auto">
          <a:xfrm>
            <a:off x="4953000" y="1219200"/>
            <a:ext cx="3984314" cy="30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5715000" y="816486"/>
            <a:ext cx="6255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Root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388026" y="4876800"/>
            <a:ext cx="807017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Fig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 map showing expression pattern of genes in leaf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eft panel) an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ot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ight panel) tissues under salinity stres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grape .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1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control; T2, 100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T3, 200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6423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isakh, Niranjan</dc:creator>
  <cp:lastModifiedBy>Baisakh, Niranjan</cp:lastModifiedBy>
  <cp:revision>1</cp:revision>
  <dcterms:created xsi:type="dcterms:W3CDTF">2015-07-17T02:53:15Z</dcterms:created>
  <dcterms:modified xsi:type="dcterms:W3CDTF">2015-07-17T02:53:33Z</dcterms:modified>
</cp:coreProperties>
</file>